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4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82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EF8C-6D10-4913-A54D-B1211A94AEA8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9003D-0D4B-4FCC-AAA7-990666984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435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EF8C-6D10-4913-A54D-B1211A94AEA8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9003D-0D4B-4FCC-AAA7-990666984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396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EF8C-6D10-4913-A54D-B1211A94AEA8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9003D-0D4B-4FCC-AAA7-990666984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835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EF8C-6D10-4913-A54D-B1211A94AEA8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9003D-0D4B-4FCC-AAA7-990666984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626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EF8C-6D10-4913-A54D-B1211A94AEA8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9003D-0D4B-4FCC-AAA7-990666984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3886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EF8C-6D10-4913-A54D-B1211A94AEA8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9003D-0D4B-4FCC-AAA7-990666984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171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EF8C-6D10-4913-A54D-B1211A94AEA8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9003D-0D4B-4FCC-AAA7-990666984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01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EF8C-6D10-4913-A54D-B1211A94AEA8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9003D-0D4B-4FCC-AAA7-990666984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75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EF8C-6D10-4913-A54D-B1211A94AEA8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9003D-0D4B-4FCC-AAA7-990666984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632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EF8C-6D10-4913-A54D-B1211A94AEA8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9003D-0D4B-4FCC-AAA7-990666984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8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7EF8C-6D10-4913-A54D-B1211A94AEA8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9003D-0D4B-4FCC-AAA7-990666984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487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C7EF8C-6D10-4913-A54D-B1211A94AEA8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59003D-0D4B-4FCC-AAA7-990666984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541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954" y="1573272"/>
            <a:ext cx="6406139" cy="345520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84954" y="5111942"/>
            <a:ext cx="688109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558-nucleotide, </a:t>
            </a:r>
            <a:r>
              <a:rPr lang="en-US" sz="1000" i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RI4</a:t>
            </a:r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like region </a:t>
            </a:r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between </a:t>
            </a:r>
            <a:r>
              <a:rPr lang="en-US" sz="1000" i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RI3</a:t>
            </a:r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and </a:t>
            </a:r>
            <a:r>
              <a:rPr lang="en-US" sz="1000" i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RI6a</a:t>
            </a:r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in </a:t>
            </a:r>
            <a:r>
              <a:rPr lang="en-US" sz="1000" i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Spicellum roseum</a:t>
            </a:r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ATTCACAATCGTATCAGTAAAATGATATCCCGATTTGACGACTTCCTCAACAGCGGGAAAAAAAAAGGAAGAAAAGAAAACTCCTGCTCCGGACGGTAGGTTCCCAGCCCTGACCGCAGACGTCATTATGGTAATCCCCATCGTTATAATCCTCTCAAGGCTTTCATTTGACTGCTAGATGTGACCTTATGGAGCTTGCCGAGGTCTATAATTTTTCCTTCGTTCCTAGCGTCGTATCATCCATCAAGGTCCTCGCCATTGATCTTCTTCATTGGCTCACGCCCCCTCCACCCCGTCGCTGAATTTGCCAGATGGTGCGCGATGAGATGCAGACCAACGGGCGTTGATGGCGATGCCGACAAGCAGGCTTCCATTTTGTTCCAATCTCTTTCTCTCTGGATGTAATGTACTATTTCGTAGATGAGGGGCCCACGCACCTGTTCAGTGGCAAGGAGGCGACCTACCTCCTGCAACCTGTGCGTCACCATGCTCTATCCCATTGAAAATTTTTGATTTACGAGAAACGTGCTTGGAGAATTAGATACGCCATCTCCCCCG</a:t>
            </a:r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84954" y="348330"/>
            <a:ext cx="770166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Figure: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LASTx result using a 558-nucleotide sequence from the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RI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RI6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tergenic region of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picellum roseum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AOM 209012 as a query against the non-redundant protein sequence at NCBI, with “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richothecium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taxid:231006)” selected in the Organism option. The nucleotide sequence of the query is shown below the BLASTx results. 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9037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</TotalTime>
  <Words>68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hp</dc:creator>
  <cp:lastModifiedBy>rhp</cp:lastModifiedBy>
  <cp:revision>11</cp:revision>
  <dcterms:created xsi:type="dcterms:W3CDTF">2017-04-25T20:55:17Z</dcterms:created>
  <dcterms:modified xsi:type="dcterms:W3CDTF">2018-03-01T17:16:14Z</dcterms:modified>
</cp:coreProperties>
</file>